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2" d="100"/>
          <a:sy n="72" d="100"/>
        </p:scale>
        <p:origin x="66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A9DDA3-55B2-4731-947A-AFC7F584107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F32D380-2DD5-458A-97B1-481EB540F56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BFED8E-9D8D-4636-9042-475E954400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E6F16-123B-432C-B876-9B68886E070E}" type="datetimeFigureOut">
              <a:rPr lang="en-US" smtClean="0"/>
              <a:t>5/1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695766-49A9-4E61-8E24-A905B36CAB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3AB9D5-581D-4AFA-81BA-2A8ED79069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22A9-0673-4528-A674-2449A9CD4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80597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DB7B5AF-E200-43BC-9CB0-EE8F11DB6D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3DF8769-0AA2-46E8-9BB6-0E0AD73365F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0792824-3945-4FF1-B775-1CCE8C220D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E6F16-123B-432C-B876-9B68886E070E}" type="datetimeFigureOut">
              <a:rPr lang="en-US" smtClean="0"/>
              <a:t>5/1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E8CE86-0689-4AAD-90E2-60D6BDAF2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2E4823D-ED21-4867-9C8D-DB2D257BD3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22A9-0673-4528-A674-2449A9CD4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889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746E083-2C77-4AE2-961B-1D32C39ECEB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E9780AA-D83D-45E1-AA73-07493B0375F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1A2990-01A5-49C6-99CD-9B4777FBBA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E6F16-123B-432C-B876-9B68886E070E}" type="datetimeFigureOut">
              <a:rPr lang="en-US" smtClean="0"/>
              <a:t>5/1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456F55-4939-4E87-9144-D730FC2F1B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3695F9-282D-49CD-B631-B3182D5F90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22A9-0673-4528-A674-2449A9CD4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8559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339005-9A3E-4A6A-A076-17461722C4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6387A2-D042-46DE-91D1-69EC38A2066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932F23-16BA-4D8D-9877-57F719AA57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E6F16-123B-432C-B876-9B68886E070E}" type="datetimeFigureOut">
              <a:rPr lang="en-US" smtClean="0"/>
              <a:t>5/1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D2B92ED-D303-4836-81A7-EE5B55C5E2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512FB1-497A-4B3D-A48D-BBA9DE2D37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22A9-0673-4528-A674-2449A9CD4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96821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BA8C09-9F6A-4C83-BF33-13C5D2E09DE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A61BE4-E5C5-4D5E-9B66-C3BAFD92EB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2DA822-0611-487C-8F22-21DC2624EC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E6F16-123B-432C-B876-9B68886E070E}" type="datetimeFigureOut">
              <a:rPr lang="en-US" smtClean="0"/>
              <a:t>5/1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EABF43-CD90-4CBD-8124-F518C62A29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5E8297-B1E7-4FA6-AF65-E897ACE35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22A9-0673-4528-A674-2449A9CD4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2846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5ECC7E-BCD4-47EE-AD24-0FDD98A1D5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35E944-109D-4E2A-BED6-78EF32C278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DD56BA8-A21C-490B-ABF3-A8C1CB6294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08A693-48C3-431B-97A6-82DB04622D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E6F16-123B-432C-B876-9B68886E070E}" type="datetimeFigureOut">
              <a:rPr lang="en-US" smtClean="0"/>
              <a:t>5/1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EA3061-6EEB-46FC-AFC6-A968765EBA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315DAA-0FC6-4FD8-B7C6-2B585D73BF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22A9-0673-4528-A674-2449A9CD4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74938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B237C4-29CF-4FE4-8E86-81E9C58E29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F99E863-9627-4940-807D-9F73ED45E0D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B5D3824-62D3-4D52-A0EE-5C4976B741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B2237B6-F007-4F24-AE80-1FB50655F43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3147FAF-CEE2-4651-9E61-C10599BECE6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A6A7765-B715-4F4F-8260-318023FFB6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E6F16-123B-432C-B876-9B68886E070E}" type="datetimeFigureOut">
              <a:rPr lang="en-US" smtClean="0"/>
              <a:t>5/19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4619ACE-8332-40F7-BDA5-52C4C8B475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EB27CA1-E9F3-43BA-9706-178098CF01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22A9-0673-4528-A674-2449A9CD4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69139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F400CB-B739-4BC9-9269-1805C221EE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184F13F-A094-4FA5-8287-17BD0FBC87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E6F16-123B-432C-B876-9B68886E070E}" type="datetimeFigureOut">
              <a:rPr lang="en-US" smtClean="0"/>
              <a:t>5/19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015DD0-8821-4B24-B84E-A60A44FAF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8ABEAC8-CC97-44FC-81A4-7E1300C6D1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22A9-0673-4528-A674-2449A9CD4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746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4A7BC0E-693F-42CD-BD30-2E5376D612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E6F16-123B-432C-B876-9B68886E070E}" type="datetimeFigureOut">
              <a:rPr lang="en-US" smtClean="0"/>
              <a:t>5/19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0CCBDD0-1577-4D4E-9BDE-FE8EDECE82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47D758A-F884-44F9-BAD5-2AF575F267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22A9-0673-4528-A674-2449A9CD4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7050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EB57ED-E299-442C-8F22-9C9DC779A8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5D1AF3-D37E-494D-B454-A07440D9AB6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BAEED9A-D4E8-4EB4-93A6-8A285566BEE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AD10F6-6477-442B-8EC8-F9F41CDA61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E6F16-123B-432C-B876-9B68886E070E}" type="datetimeFigureOut">
              <a:rPr lang="en-US" smtClean="0"/>
              <a:t>5/1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1B7A61-484F-40FB-9B74-4B96CB42DE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B434D6-A727-4337-B518-E7008E32A8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22A9-0673-4528-A674-2449A9CD4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23235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321BD5-07C4-4252-9A3A-628AB46663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3A9997C-052F-4DF4-8C7D-30B13EBDCFB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AF5AB97-82BD-4362-8767-7CDE7D61754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9F1D5D-0A1C-46D7-8A1E-BF6595E50E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4E6F16-123B-432C-B876-9B68886E070E}" type="datetimeFigureOut">
              <a:rPr lang="en-US" smtClean="0"/>
              <a:t>5/1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BB281E1-7CE0-4C4D-87BB-2D9B74D909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884D22A-30C1-4304-819B-3A6F1AFA27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9322A9-0673-4528-A674-2449A9CD4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5244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46769BF-B96E-4717-A666-A9E1A7BC4D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2F22170-E3EF-4901-A36B-8F602DAF5B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47E8915-CDB4-4402-B0A4-E0788501C70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4E6F16-123B-432C-B876-9B68886E070E}" type="datetimeFigureOut">
              <a:rPr lang="en-US" smtClean="0"/>
              <a:t>5/1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FEB67E1-883C-4229-9C91-3A04A0F2E3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FBF3BF-C21C-4DDC-AAC4-DDE5557EDB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9322A9-0673-4528-A674-2449A9CD4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6510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31BBD7-EA34-4C78-9C1C-904C95BC0A4A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R codes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8C21FD5-D56F-4B9E-9DC7-D84791665168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R codes used to fit the models</a:t>
            </a:r>
          </a:p>
        </p:txBody>
      </p:sp>
    </p:spTree>
    <p:extLst>
      <p:ext uri="{BB962C8B-B14F-4D97-AF65-F5344CB8AC3E}">
        <p14:creationId xmlns:p14="http://schemas.microsoft.com/office/powerpoint/2010/main" val="179293274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73DFD00F-2D63-45A2-8830-3727F2F65AAF}"/>
              </a:ext>
            </a:extLst>
          </p:cNvPr>
          <p:cNvSpPr/>
          <p:nvPr/>
        </p:nvSpPr>
        <p:spPr>
          <a:xfrm>
            <a:off x="3048000" y="612845"/>
            <a:ext cx="6096000" cy="5632311"/>
          </a:xfrm>
          <a:prstGeom prst="rect">
            <a:avLst/>
          </a:prstGeom>
        </p:spPr>
        <p:txBody>
          <a:bodyPr>
            <a:spAutoFit/>
          </a:bodyPr>
          <a:lstStyle/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cd4=read.csv(</a:t>
            </a:r>
            <a:r>
              <a:rPr lang="en-US" dirty="0" err="1"/>
              <a:t>file.choose</a:t>
            </a:r>
            <a:r>
              <a:rPr lang="en-US" dirty="0"/>
              <a:t>()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attach(cd4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cd4$Sex &lt;- relevel(cd4$Sex, ref = "Male"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cd4$WHOStage &lt;- relevel(cd4$WHOStage, ref = "Stage2"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cd4$FunctionaStatus &lt;- relevel(cd4$FunctionaStatus, ref = "Ambulatory"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cd4$MaritalStatus&lt;- relevel(cd4$MaritalStatus, ref = "divorced"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cd4$LevelEdu&lt;- relevel(cd4$LevelEdu, ref = "secondary"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cd4$TBStatus&lt;- relevel(cd4$TBStatus, ref = "Positive"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library(lme4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library(Matrix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library(MASS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pm &lt;- </a:t>
            </a:r>
            <a:r>
              <a:rPr lang="en-US" dirty="0" err="1"/>
              <a:t>glm</a:t>
            </a:r>
            <a:r>
              <a:rPr lang="en-US" dirty="0"/>
              <a:t>(CD4 ~Time+Sex+MaritalStatus+LevelEdu+FunctionaStatus+WHOStage+TBStatus+Age+Weight+BaseCD4, data = cd4, family = </a:t>
            </a:r>
            <a:r>
              <a:rPr lang="en-US" dirty="0" err="1"/>
              <a:t>poisson</a:t>
            </a:r>
            <a:r>
              <a:rPr lang="en-US" dirty="0"/>
              <a:t>) #To fit the ordinary Poisson model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summary(pm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library(</a:t>
            </a:r>
            <a:r>
              <a:rPr lang="en-US" dirty="0" err="1"/>
              <a:t>xtable</a:t>
            </a:r>
            <a:r>
              <a:rPr lang="en-US" dirty="0"/>
              <a:t>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 err="1"/>
              <a:t>xtable</a:t>
            </a:r>
            <a:r>
              <a:rPr lang="en-US" dirty="0"/>
              <a:t>(pm)</a:t>
            </a:r>
          </a:p>
        </p:txBody>
      </p:sp>
    </p:spTree>
    <p:extLst>
      <p:ext uri="{BB962C8B-B14F-4D97-AF65-F5344CB8AC3E}">
        <p14:creationId xmlns:p14="http://schemas.microsoft.com/office/powerpoint/2010/main" val="13191768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>
            <a:extLst>
              <a:ext uri="{FF2B5EF4-FFF2-40B4-BE49-F238E27FC236}">
                <a16:creationId xmlns:a16="http://schemas.microsoft.com/office/drawing/2014/main" id="{E09054FF-BEA0-4402-B890-376EB7DB1497}"/>
              </a:ext>
            </a:extLst>
          </p:cNvPr>
          <p:cNvSpPr/>
          <p:nvPr/>
        </p:nvSpPr>
        <p:spPr>
          <a:xfrm>
            <a:off x="3048000" y="751344"/>
            <a:ext cx="6096000" cy="5355312"/>
          </a:xfrm>
          <a:prstGeom prst="rect">
            <a:avLst/>
          </a:prstGeom>
        </p:spPr>
        <p:txBody>
          <a:bodyPr>
            <a:spAutoFit/>
          </a:bodyPr>
          <a:lstStyle/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pnml &lt;- </a:t>
            </a:r>
            <a:r>
              <a:rPr lang="en-US" dirty="0" err="1"/>
              <a:t>glmer</a:t>
            </a:r>
            <a:r>
              <a:rPr lang="en-US" dirty="0"/>
              <a:t>(CD4~Time+MaritalStatus+WHOStage+FunctionaStatus+LevelEdu+TBStatus+Sex+Age+Weight+BaseCD4+(1|Id),family=</a:t>
            </a:r>
            <a:r>
              <a:rPr lang="en-US" dirty="0" err="1"/>
              <a:t>poisson,data</a:t>
            </a:r>
            <a:r>
              <a:rPr lang="en-US" dirty="0"/>
              <a:t>=cd4)#To fit the Poisson-Normal with random intercept model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summary(pnml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pnm2 &lt;- </a:t>
            </a:r>
            <a:r>
              <a:rPr lang="en-US" dirty="0" err="1"/>
              <a:t>glmer</a:t>
            </a:r>
            <a:r>
              <a:rPr lang="en-US" dirty="0"/>
              <a:t>(CD4~Time+MaritalStatus+WHOStage+FunctionaStatus+LevelEdu+TBStatus+Sex+Age+Weight+BaseCD4+(1+Time|Id),family=</a:t>
            </a:r>
            <a:r>
              <a:rPr lang="en-US" dirty="0" err="1"/>
              <a:t>poisson,data</a:t>
            </a:r>
            <a:r>
              <a:rPr lang="en-US" dirty="0"/>
              <a:t>=cd4)#To fit the Poisson-Normal with both random intercept and random slope model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summary(pnm2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 err="1"/>
              <a:t>pgm</a:t>
            </a:r>
            <a:r>
              <a:rPr lang="en-US" dirty="0"/>
              <a:t> &lt;- </a:t>
            </a:r>
            <a:r>
              <a:rPr lang="en-US" dirty="0" err="1"/>
              <a:t>glm.nb</a:t>
            </a:r>
            <a:r>
              <a:rPr lang="en-US" dirty="0"/>
              <a:t>(CD4 ~Time+Sex+MaritalStatus+LevelEdu+FunctionaStatus+WHOStage+TBStatus+Age+Weight+BaseCD4, data = cd4)#To fit the Poisson-Gamma (Negative Binomial) model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summary(</a:t>
            </a:r>
            <a:r>
              <a:rPr lang="en-US" dirty="0" err="1"/>
              <a:t>pgm</a:t>
            </a:r>
            <a:r>
              <a:rPr lang="en-US" dirty="0"/>
              <a:t>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 err="1"/>
              <a:t>cbind</a:t>
            </a:r>
            <a:r>
              <a:rPr lang="en-US" dirty="0"/>
              <a:t>(Estimate = </a:t>
            </a:r>
            <a:r>
              <a:rPr lang="en-US" dirty="0" err="1"/>
              <a:t>coef</a:t>
            </a:r>
            <a:r>
              <a:rPr lang="en-US" dirty="0"/>
              <a:t>(</a:t>
            </a:r>
            <a:r>
              <a:rPr lang="en-US" dirty="0" err="1"/>
              <a:t>pgm</a:t>
            </a:r>
            <a:r>
              <a:rPr lang="en-US" dirty="0"/>
              <a:t>), </a:t>
            </a:r>
            <a:r>
              <a:rPr lang="en-US" dirty="0" err="1"/>
              <a:t>confint</a:t>
            </a:r>
            <a:r>
              <a:rPr lang="en-US" dirty="0"/>
              <a:t>(</a:t>
            </a:r>
            <a:r>
              <a:rPr lang="en-US" dirty="0" err="1"/>
              <a:t>pgm</a:t>
            </a:r>
            <a:r>
              <a:rPr lang="en-US" dirty="0"/>
              <a:t>)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summary(</a:t>
            </a:r>
            <a:r>
              <a:rPr lang="en-US" dirty="0" err="1"/>
              <a:t>pgm</a:t>
            </a:r>
            <a:r>
              <a:rPr lang="en-US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0457212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A11EF570-B9B4-44BA-930A-7998BD362AA5}"/>
              </a:ext>
            </a:extLst>
          </p:cNvPr>
          <p:cNvSpPr/>
          <p:nvPr/>
        </p:nvSpPr>
        <p:spPr>
          <a:xfrm>
            <a:off x="3048000" y="1305342"/>
            <a:ext cx="6096000" cy="4524315"/>
          </a:xfrm>
          <a:prstGeom prst="rect">
            <a:avLst/>
          </a:prstGeom>
        </p:spPr>
        <p:txBody>
          <a:bodyPr>
            <a:spAutoFit/>
          </a:bodyPr>
          <a:lstStyle/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pgnm&lt;- </a:t>
            </a:r>
            <a:r>
              <a:rPr lang="en-US" dirty="0" err="1"/>
              <a:t>glmer.nb</a:t>
            </a:r>
            <a:r>
              <a:rPr lang="en-US" dirty="0"/>
              <a:t>(CD4~Time+FunctionaStatus+TBStatus+Sex+Age+Weight+BaseCD4+(1|Id),data=cd4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summary(pgnm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pgnm1&lt;-update(pgnm,~Time+MaritalStatus+WHOStage+FunctionaStatus+LevelEdu+TBStatus+Sex+Weight+Age+BaseCD4+(1|Id))#To fit the Poisson-Gamma-Normal with random intercept model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summary(pgnm1)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pgnm2&lt;-update(pgnm,~Time+MaritalStatus+WHOStage+FunctionaStatus+LevelEdu+TBStatus+Sex+Weight+Age+BaseCD4+(1+Time|Id))#To fit the Poisson-Gamma-Normal with both random intercept and random slope model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en-US" dirty="0"/>
              <a:t>summary(pgnm2)</a:t>
            </a:r>
          </a:p>
        </p:txBody>
      </p:sp>
    </p:spTree>
    <p:extLst>
      <p:ext uri="{BB962C8B-B14F-4D97-AF65-F5344CB8AC3E}">
        <p14:creationId xmlns:p14="http://schemas.microsoft.com/office/powerpoint/2010/main" val="20878684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469</Words>
  <Application>Microsoft Office PowerPoint</Application>
  <PresentationFormat>Widescreen</PresentationFormat>
  <Paragraphs>31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Wingdings</vt:lpstr>
      <vt:lpstr>Office Theme</vt:lpstr>
      <vt:lpstr>R codes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 codes</dc:title>
  <dc:creator>Belay D</dc:creator>
  <cp:lastModifiedBy>Belay D</cp:lastModifiedBy>
  <cp:revision>4</cp:revision>
  <dcterms:created xsi:type="dcterms:W3CDTF">2019-05-19T19:16:33Z</dcterms:created>
  <dcterms:modified xsi:type="dcterms:W3CDTF">2019-05-19T19:21:12Z</dcterms:modified>
</cp:coreProperties>
</file>